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8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5C1CB-B609-477F-8699-F66D802EB9D4}" type="datetimeFigureOut">
              <a:rPr lang="zh-CN" altLang="en-US" smtClean="0"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70E77-51CD-439D-A2A9-CA45AAADB0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6" y="12192"/>
            <a:ext cx="2631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Supplementary Fig.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1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87552" y="2291687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图片 5" descr="Supplementary Fig.1A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tretch>
            <a:fillRect/>
          </a:stretch>
        </p:blipFill>
        <p:spPr>
          <a:xfrm>
            <a:off x="1600200" y="2971800"/>
            <a:ext cx="1329690" cy="124249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-5400000">
            <a:off x="497886" y="3323382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miR-34a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-2400000">
            <a:off x="1396638" y="4315137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T-8</a:t>
            </a:r>
          </a:p>
        </p:txBody>
      </p:sp>
      <p:sp>
        <p:nvSpPr>
          <p:cNvPr id="9" name="TextBox 8"/>
          <p:cNvSpPr txBox="1"/>
          <p:nvPr/>
        </p:nvSpPr>
        <p:spPr>
          <a:xfrm rot="-2400000">
            <a:off x="1723682" y="4304496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sp>
        <p:nvSpPr>
          <p:cNvPr id="10" name="TextBox 9"/>
          <p:cNvSpPr txBox="1"/>
          <p:nvPr/>
        </p:nvSpPr>
        <p:spPr>
          <a:xfrm rot="-2400000">
            <a:off x="2085375" y="4304496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lum contrast="20000"/>
          </a:blip>
          <a:srcRect/>
          <a:stretch>
            <a:fillRect/>
          </a:stretch>
        </p:blipFill>
        <p:spPr bwMode="auto">
          <a:xfrm>
            <a:off x="1838326" y="2595566"/>
            <a:ext cx="114299" cy="247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>
            <a:off x="1871086" y="2549431"/>
            <a:ext cx="948314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mic NC</a:t>
            </a:r>
          </a:p>
          <a:p>
            <a:pPr>
              <a:lnSpc>
                <a:spcPts val="1000"/>
              </a:lnSpc>
            </a:pP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49713" y="2286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-5400000">
            <a:off x="2693842" y="3320431"/>
            <a:ext cx="1896355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poptosis (OD @ 405nm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图片 14" descr="Supplementary Fig.1B.jpg"/>
          <p:cNvPicPr>
            <a:picLocks noChangeAspect="1"/>
          </p:cNvPicPr>
          <p:nvPr/>
        </p:nvPicPr>
        <p:blipFill>
          <a:blip r:embed="rId4" cstate="print">
            <a:lum contrast="20000"/>
          </a:blip>
          <a:stretch>
            <a:fillRect/>
          </a:stretch>
        </p:blipFill>
        <p:spPr>
          <a:xfrm>
            <a:off x="3880673" y="2943225"/>
            <a:ext cx="1834327" cy="1292224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-2400000">
            <a:off x="3810460" y="4324662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T-8</a:t>
            </a:r>
          </a:p>
        </p:txBody>
      </p:sp>
      <p:sp>
        <p:nvSpPr>
          <p:cNvPr id="17" name="TextBox 16"/>
          <p:cNvSpPr txBox="1"/>
          <p:nvPr/>
        </p:nvSpPr>
        <p:spPr>
          <a:xfrm rot="-2400000">
            <a:off x="4289648" y="4314021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sp>
        <p:nvSpPr>
          <p:cNvPr id="18" name="TextBox 17"/>
          <p:cNvSpPr txBox="1"/>
          <p:nvPr/>
        </p:nvSpPr>
        <p:spPr>
          <a:xfrm rot="-2400000">
            <a:off x="4823048" y="4314021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196085" y="386422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96818" y="362223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379337" y="350626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791560" y="367204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867017" y="367204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276638" y="343118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67706" y="351258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461377" y="2955024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967006" y="335089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84158" y="316949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693801" y="384080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184826" y="386236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图片 30" descr="Supplementary Fig.1B-mark.jpg"/>
          <p:cNvPicPr>
            <a:picLocks noChangeAspect="1"/>
          </p:cNvPicPr>
          <p:nvPr/>
        </p:nvPicPr>
        <p:blipFill>
          <a:blip r:embed="rId5" cstate="print">
            <a:lum contrast="20000"/>
          </a:blip>
          <a:stretch>
            <a:fillRect/>
          </a:stretch>
        </p:blipFill>
        <p:spPr>
          <a:xfrm>
            <a:off x="4337762" y="2491553"/>
            <a:ext cx="114281" cy="391191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4390146" y="2471110"/>
            <a:ext cx="1401054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Naïve</a:t>
            </a:r>
          </a:p>
          <a:p>
            <a:pPr>
              <a:lnSpc>
                <a:spcPts val="700"/>
              </a:lnSpc>
            </a:pP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Cisplatin</a:t>
            </a:r>
            <a:endParaRPr lang="en-US" altLang="zh-CN" sz="700" b="1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ts val="700"/>
              </a:lnSpc>
            </a:pP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Cisplatin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 + Mimic NC</a:t>
            </a:r>
          </a:p>
          <a:p>
            <a:pPr>
              <a:lnSpc>
                <a:spcPts val="700"/>
              </a:lnSpc>
            </a:pP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Cisplatin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 + miR-34a mimi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49</Words>
  <Application>Microsoft Office PowerPoint</Application>
  <PresentationFormat>全屏显示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6</cp:revision>
  <dcterms:created xsi:type="dcterms:W3CDTF">2018-06-06T08:12:36Z</dcterms:created>
  <dcterms:modified xsi:type="dcterms:W3CDTF">2018-06-06T15:10:34Z</dcterms:modified>
</cp:coreProperties>
</file>